
<file path=[Content_Types].xml><?xml version="1.0" encoding="utf-8"?>
<Types xmlns="http://schemas.openxmlformats.org/package/2006/content-types"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263" r:id="rId5"/>
    <p:sldId id="25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 showGuides="1">
      <p:cViewPr varScale="1">
        <p:scale>
          <a:sx n="66" d="100"/>
          <a:sy n="66" d="100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tukhov, Pavel A" userId="c48bba25-b19d-4f19-812a-3a789a6c2dec" providerId="ADAL" clId="{ECEBD42D-3DB9-3E44-8F45-CFD4AECF89CA}"/>
    <pc:docChg chg="custSel modSld">
      <pc:chgData name="Petukhov, Pavel A" userId="c48bba25-b19d-4f19-812a-3a789a6c2dec" providerId="ADAL" clId="{ECEBD42D-3DB9-3E44-8F45-CFD4AECF89CA}" dt="2023-03-10T20:38:36.673" v="59" actId="20577"/>
      <pc:docMkLst>
        <pc:docMk/>
      </pc:docMkLst>
      <pc:sldChg chg="delSp mod">
        <pc:chgData name="Petukhov, Pavel A" userId="c48bba25-b19d-4f19-812a-3a789a6c2dec" providerId="ADAL" clId="{ECEBD42D-3DB9-3E44-8F45-CFD4AECF89CA}" dt="2023-03-10T20:38:04.392" v="32" actId="478"/>
        <pc:sldMkLst>
          <pc:docMk/>
          <pc:sldMk cId="993465913" sldId="257"/>
        </pc:sldMkLst>
        <pc:spChg chg="del">
          <ac:chgData name="Petukhov, Pavel A" userId="c48bba25-b19d-4f19-812a-3a789a6c2dec" providerId="ADAL" clId="{ECEBD42D-3DB9-3E44-8F45-CFD4AECF89CA}" dt="2023-03-10T20:38:04.392" v="32" actId="478"/>
          <ac:spMkLst>
            <pc:docMk/>
            <pc:sldMk cId="993465913" sldId="257"/>
            <ac:spMk id="34" creationId="{D0931060-2F51-46AC-A2C2-11937A083DF5}"/>
          </ac:spMkLst>
        </pc:spChg>
      </pc:sldChg>
      <pc:sldChg chg="delSp mod">
        <pc:chgData name="Petukhov, Pavel A" userId="c48bba25-b19d-4f19-812a-3a789a6c2dec" providerId="ADAL" clId="{ECEBD42D-3DB9-3E44-8F45-CFD4AECF89CA}" dt="2023-03-10T20:38:07.359" v="33" actId="478"/>
        <pc:sldMkLst>
          <pc:docMk/>
          <pc:sldMk cId="3768732664" sldId="261"/>
        </pc:sldMkLst>
        <pc:spChg chg="del">
          <ac:chgData name="Petukhov, Pavel A" userId="c48bba25-b19d-4f19-812a-3a789a6c2dec" providerId="ADAL" clId="{ECEBD42D-3DB9-3E44-8F45-CFD4AECF89CA}" dt="2023-03-10T20:38:07.359" v="33" actId="478"/>
          <ac:spMkLst>
            <pc:docMk/>
            <pc:sldMk cId="3768732664" sldId="261"/>
            <ac:spMk id="34" creationId="{FBF2D9F4-40BF-4B90-BE93-32891BF36A0E}"/>
          </ac:spMkLst>
        </pc:spChg>
      </pc:sldChg>
      <pc:sldChg chg="delSp modSp mod">
        <pc:chgData name="Petukhov, Pavel A" userId="c48bba25-b19d-4f19-812a-3a789a6c2dec" providerId="ADAL" clId="{ECEBD42D-3DB9-3E44-8F45-CFD4AECF89CA}" dt="2023-03-10T20:38:10.654" v="35" actId="478"/>
        <pc:sldMkLst>
          <pc:docMk/>
          <pc:sldMk cId="1968887079" sldId="262"/>
        </pc:sldMkLst>
        <pc:spChg chg="del mod">
          <ac:chgData name="Petukhov, Pavel A" userId="c48bba25-b19d-4f19-812a-3a789a6c2dec" providerId="ADAL" clId="{ECEBD42D-3DB9-3E44-8F45-CFD4AECF89CA}" dt="2023-03-10T20:38:10.654" v="35" actId="478"/>
          <ac:spMkLst>
            <pc:docMk/>
            <pc:sldMk cId="1968887079" sldId="262"/>
            <ac:spMk id="25" creationId="{BC900FCD-66E3-4C2C-B896-DE42A35C9A34}"/>
          </ac:spMkLst>
        </pc:spChg>
      </pc:sldChg>
      <pc:sldChg chg="modSp mod">
        <pc:chgData name="Petukhov, Pavel A" userId="c48bba25-b19d-4f19-812a-3a789a6c2dec" providerId="ADAL" clId="{ECEBD42D-3DB9-3E44-8F45-CFD4AECF89CA}" dt="2023-03-10T20:38:36.673" v="59" actId="20577"/>
        <pc:sldMkLst>
          <pc:docMk/>
          <pc:sldMk cId="2515979428" sldId="263"/>
        </pc:sldMkLst>
        <pc:spChg chg="mod">
          <ac:chgData name="Petukhov, Pavel A" userId="c48bba25-b19d-4f19-812a-3a789a6c2dec" providerId="ADAL" clId="{ECEBD42D-3DB9-3E44-8F45-CFD4AECF89CA}" dt="2023-03-10T20:38:36.673" v="59" actId="20577"/>
          <ac:spMkLst>
            <pc:docMk/>
            <pc:sldMk cId="2515979428" sldId="263"/>
            <ac:spMk id="2" creationId="{82C08C7F-1555-4700-98CA-5D02EE1362C2}"/>
          </ac:spMkLst>
        </pc:spChg>
        <pc:spChg chg="mod">
          <ac:chgData name="Petukhov, Pavel A" userId="c48bba25-b19d-4f19-812a-3a789a6c2dec" providerId="ADAL" clId="{ECEBD42D-3DB9-3E44-8F45-CFD4AECF89CA}" dt="2023-03-08T00:15:39.191" v="24" actId="20577"/>
          <ac:spMkLst>
            <pc:docMk/>
            <pc:sldMk cId="2515979428" sldId="263"/>
            <ac:spMk id="3" creationId="{DB6D10D1-DA43-46FA-AA22-685F880B1CE3}"/>
          </ac:spMkLst>
        </pc:spChg>
      </pc:sldChg>
      <pc:sldChg chg="delSp mod">
        <pc:chgData name="Petukhov, Pavel A" userId="c48bba25-b19d-4f19-812a-3a789a6c2dec" providerId="ADAL" clId="{ECEBD42D-3DB9-3E44-8F45-CFD4AECF89CA}" dt="2023-03-10T20:38:14.669" v="36" actId="478"/>
        <pc:sldMkLst>
          <pc:docMk/>
          <pc:sldMk cId="1957108625" sldId="264"/>
        </pc:sldMkLst>
        <pc:spChg chg="del">
          <ac:chgData name="Petukhov, Pavel A" userId="c48bba25-b19d-4f19-812a-3a789a6c2dec" providerId="ADAL" clId="{ECEBD42D-3DB9-3E44-8F45-CFD4AECF89CA}" dt="2023-03-10T20:38:14.669" v="36" actId="478"/>
          <ac:spMkLst>
            <pc:docMk/>
            <pc:sldMk cId="1957108625" sldId="264"/>
            <ac:spMk id="22" creationId="{F3CF4493-DC27-902E-F569-CA51BA060514}"/>
          </ac:spMkLst>
        </pc:spChg>
      </pc:sldChg>
    </pc:docChg>
  </pc:docChgLst>
  <pc:docChgLst>
    <pc:chgData name="David L Williams" userId="94b5e154-46c7-48ee-9f2d-7b90dd615861" providerId="ADAL" clId="{AD4CB5B1-1484-47F1-98AB-16FFBFDB40AB}"/>
    <pc:docChg chg="custSel addSld modSld sldOrd">
      <pc:chgData name="David L Williams" userId="94b5e154-46c7-48ee-9f2d-7b90dd615861" providerId="ADAL" clId="{AD4CB5B1-1484-47F1-98AB-16FFBFDB40AB}" dt="2023-03-10T20:04:56.176" v="153"/>
      <pc:docMkLst>
        <pc:docMk/>
      </pc:docMkLst>
      <pc:sldChg chg="modSp mod">
        <pc:chgData name="David L Williams" userId="94b5e154-46c7-48ee-9f2d-7b90dd615861" providerId="ADAL" clId="{AD4CB5B1-1484-47F1-98AB-16FFBFDB40AB}" dt="2023-03-10T20:04:18.531" v="151" actId="20577"/>
        <pc:sldMkLst>
          <pc:docMk/>
          <pc:sldMk cId="2515979428" sldId="263"/>
        </pc:sldMkLst>
        <pc:spChg chg="mod">
          <ac:chgData name="David L Williams" userId="94b5e154-46c7-48ee-9f2d-7b90dd615861" providerId="ADAL" clId="{AD4CB5B1-1484-47F1-98AB-16FFBFDB40AB}" dt="2023-03-10T20:04:18.531" v="151" actId="20577"/>
          <ac:spMkLst>
            <pc:docMk/>
            <pc:sldMk cId="2515979428" sldId="263"/>
            <ac:spMk id="2" creationId="{82C08C7F-1555-4700-98CA-5D02EE1362C2}"/>
          </ac:spMkLst>
        </pc:spChg>
      </pc:sldChg>
      <pc:sldChg chg="addSp delSp modSp new mod ord">
        <pc:chgData name="David L Williams" userId="94b5e154-46c7-48ee-9f2d-7b90dd615861" providerId="ADAL" clId="{AD4CB5B1-1484-47F1-98AB-16FFBFDB40AB}" dt="2023-03-10T20:04:56.176" v="153"/>
        <pc:sldMkLst>
          <pc:docMk/>
          <pc:sldMk cId="1957108625" sldId="264"/>
        </pc:sldMkLst>
        <pc:spChg chg="add mod">
          <ac:chgData name="David L Williams" userId="94b5e154-46c7-48ee-9f2d-7b90dd615861" providerId="ADAL" clId="{AD4CB5B1-1484-47F1-98AB-16FFBFDB40AB}" dt="2023-03-10T20:03:21.082" v="118" actId="1076"/>
          <ac:spMkLst>
            <pc:docMk/>
            <pc:sldMk cId="1957108625" sldId="264"/>
            <ac:spMk id="21" creationId="{91F81078-93D1-8EBB-776A-037C813E6091}"/>
          </ac:spMkLst>
        </pc:spChg>
        <pc:spChg chg="add mod">
          <ac:chgData name="David L Williams" userId="94b5e154-46c7-48ee-9f2d-7b90dd615861" providerId="ADAL" clId="{AD4CB5B1-1484-47F1-98AB-16FFBFDB40AB}" dt="2023-03-10T20:04:08.114" v="140" actId="1076"/>
          <ac:spMkLst>
            <pc:docMk/>
            <pc:sldMk cId="1957108625" sldId="264"/>
            <ac:spMk id="22" creationId="{F3CF4493-DC27-902E-F569-CA51BA060514}"/>
          </ac:spMkLst>
        </pc:spChg>
        <pc:picChg chg="add mod">
          <ac:chgData name="David L Williams" userId="94b5e154-46c7-48ee-9f2d-7b90dd615861" providerId="ADAL" clId="{AD4CB5B1-1484-47F1-98AB-16FFBFDB40AB}" dt="2023-03-10T19:57:28.251" v="64" actId="1038"/>
          <ac:picMkLst>
            <pc:docMk/>
            <pc:sldMk cId="1957108625" sldId="264"/>
            <ac:picMk id="2" creationId="{EB99EFAE-CDB4-CEDD-31E0-EDC9EF58B84C}"/>
          </ac:picMkLst>
        </pc:picChg>
        <pc:picChg chg="add del mod">
          <ac:chgData name="David L Williams" userId="94b5e154-46c7-48ee-9f2d-7b90dd615861" providerId="ADAL" clId="{AD4CB5B1-1484-47F1-98AB-16FFBFDB40AB}" dt="2023-03-10T19:56:52.596" v="26" actId="478"/>
          <ac:picMkLst>
            <pc:docMk/>
            <pc:sldMk cId="1957108625" sldId="264"/>
            <ac:picMk id="3" creationId="{1142FF76-7884-6EB8-3A32-812FEF8E2F3A}"/>
          </ac:picMkLst>
        </pc:picChg>
        <pc:picChg chg="add mod">
          <ac:chgData name="David L Williams" userId="94b5e154-46c7-48ee-9f2d-7b90dd615861" providerId="ADAL" clId="{AD4CB5B1-1484-47F1-98AB-16FFBFDB40AB}" dt="2023-03-10T19:57:28.251" v="64" actId="1038"/>
          <ac:picMkLst>
            <pc:docMk/>
            <pc:sldMk cId="1957108625" sldId="264"/>
            <ac:picMk id="4" creationId="{03BB9AD2-FFD2-712F-B784-5F4855F2D008}"/>
          </ac:picMkLst>
        </pc:picChg>
        <pc:picChg chg="add del mod">
          <ac:chgData name="David L Williams" userId="94b5e154-46c7-48ee-9f2d-7b90dd615861" providerId="ADAL" clId="{AD4CB5B1-1484-47F1-98AB-16FFBFDB40AB}" dt="2023-03-10T19:54:33.341" v="24" actId="478"/>
          <ac:picMkLst>
            <pc:docMk/>
            <pc:sldMk cId="1957108625" sldId="264"/>
            <ac:picMk id="5" creationId="{D3F7E6EF-EE98-6B4A-AB89-80B5012DFC10}"/>
          </ac:picMkLst>
        </pc:picChg>
        <pc:picChg chg="add del mod">
          <ac:chgData name="David L Williams" userId="94b5e154-46c7-48ee-9f2d-7b90dd615861" providerId="ADAL" clId="{AD4CB5B1-1484-47F1-98AB-16FFBFDB40AB}" dt="2023-03-10T19:54:34.102" v="25" actId="478"/>
          <ac:picMkLst>
            <pc:docMk/>
            <pc:sldMk cId="1957108625" sldId="264"/>
            <ac:picMk id="6" creationId="{F671F5F3-CD01-80A9-F3AC-5865166843C6}"/>
          </ac:picMkLst>
        </pc:picChg>
        <pc:picChg chg="add mod">
          <ac:chgData name="David L Williams" userId="94b5e154-46c7-48ee-9f2d-7b90dd615861" providerId="ADAL" clId="{AD4CB5B1-1484-47F1-98AB-16FFBFDB40AB}" dt="2023-03-10T19:57:28.251" v="64" actId="1038"/>
          <ac:picMkLst>
            <pc:docMk/>
            <pc:sldMk cId="1957108625" sldId="264"/>
            <ac:picMk id="7" creationId="{EC0720EC-8D36-7ABC-93B0-881063D12BF3}"/>
          </ac:picMkLst>
        </pc:picChg>
        <pc:picChg chg="add mod">
          <ac:chgData name="David L Williams" userId="94b5e154-46c7-48ee-9f2d-7b90dd615861" providerId="ADAL" clId="{AD4CB5B1-1484-47F1-98AB-16FFBFDB40AB}" dt="2023-03-10T19:58:57.053" v="92" actId="1035"/>
          <ac:picMkLst>
            <pc:docMk/>
            <pc:sldMk cId="1957108625" sldId="264"/>
            <ac:picMk id="8" creationId="{1E5030DE-D464-583B-6B4C-027D98B98E63}"/>
          </ac:picMkLst>
        </pc:picChg>
        <pc:picChg chg="add mod">
          <ac:chgData name="David L Williams" userId="94b5e154-46c7-48ee-9f2d-7b90dd615861" providerId="ADAL" clId="{AD4CB5B1-1484-47F1-98AB-16FFBFDB40AB}" dt="2023-03-10T19:58:57.053" v="92" actId="1035"/>
          <ac:picMkLst>
            <pc:docMk/>
            <pc:sldMk cId="1957108625" sldId="264"/>
            <ac:picMk id="9" creationId="{39334967-A36F-02A7-C1CA-369F79B2AC41}"/>
          </ac:picMkLst>
        </pc:picChg>
        <pc:picChg chg="add mod">
          <ac:chgData name="David L Williams" userId="94b5e154-46c7-48ee-9f2d-7b90dd615861" providerId="ADAL" clId="{AD4CB5B1-1484-47F1-98AB-16FFBFDB40AB}" dt="2023-03-10T19:58:57.053" v="92" actId="1035"/>
          <ac:picMkLst>
            <pc:docMk/>
            <pc:sldMk cId="1957108625" sldId="264"/>
            <ac:picMk id="10" creationId="{08B8B39C-B57F-A74D-2F53-26E77B2DB5A1}"/>
          </ac:picMkLst>
        </pc:picChg>
        <pc:picChg chg="add mod">
          <ac:chgData name="David L Williams" userId="94b5e154-46c7-48ee-9f2d-7b90dd615861" providerId="ADAL" clId="{AD4CB5B1-1484-47F1-98AB-16FFBFDB40AB}" dt="2023-03-10T19:58:48.167" v="80" actId="1076"/>
          <ac:picMkLst>
            <pc:docMk/>
            <pc:sldMk cId="1957108625" sldId="264"/>
            <ac:picMk id="12" creationId="{817930AA-C02D-3F28-484D-E7511894AB62}"/>
          </ac:picMkLst>
        </pc:picChg>
        <pc:picChg chg="add mod">
          <ac:chgData name="David L Williams" userId="94b5e154-46c7-48ee-9f2d-7b90dd615861" providerId="ADAL" clId="{AD4CB5B1-1484-47F1-98AB-16FFBFDB40AB}" dt="2023-03-10T19:59:19.891" v="94" actId="1076"/>
          <ac:picMkLst>
            <pc:docMk/>
            <pc:sldMk cId="1957108625" sldId="264"/>
            <ac:picMk id="14" creationId="{C06826CF-ACF0-C781-7E31-3D14FE4995B9}"/>
          </ac:picMkLst>
        </pc:picChg>
        <pc:picChg chg="add mod">
          <ac:chgData name="David L Williams" userId="94b5e154-46c7-48ee-9f2d-7b90dd615861" providerId="ADAL" clId="{AD4CB5B1-1484-47F1-98AB-16FFBFDB40AB}" dt="2023-03-10T20:01:40.044" v="107" actId="1076"/>
          <ac:picMkLst>
            <pc:docMk/>
            <pc:sldMk cId="1957108625" sldId="264"/>
            <ac:picMk id="15" creationId="{30E6407C-4F29-B65F-AAB7-4318B45E42C4}"/>
          </ac:picMkLst>
        </pc:picChg>
        <pc:picChg chg="add del mod">
          <ac:chgData name="David L Williams" userId="94b5e154-46c7-48ee-9f2d-7b90dd615861" providerId="ADAL" clId="{AD4CB5B1-1484-47F1-98AB-16FFBFDB40AB}" dt="2023-03-10T20:01:27.212" v="103" actId="478"/>
          <ac:picMkLst>
            <pc:docMk/>
            <pc:sldMk cId="1957108625" sldId="264"/>
            <ac:picMk id="16" creationId="{DCC0324E-C019-99F3-B1A0-A51BD01EBA3B}"/>
          </ac:picMkLst>
        </pc:picChg>
        <pc:picChg chg="add mod">
          <ac:chgData name="David L Williams" userId="94b5e154-46c7-48ee-9f2d-7b90dd615861" providerId="ADAL" clId="{AD4CB5B1-1484-47F1-98AB-16FFBFDB40AB}" dt="2023-03-10T20:01:44.621" v="108" actId="1076"/>
          <ac:picMkLst>
            <pc:docMk/>
            <pc:sldMk cId="1957108625" sldId="264"/>
            <ac:picMk id="17" creationId="{F9CBD1EB-3517-88C7-E18B-42577CDF5D9C}"/>
          </ac:picMkLst>
        </pc:picChg>
        <pc:picChg chg="add mod">
          <ac:chgData name="David L Williams" userId="94b5e154-46c7-48ee-9f2d-7b90dd615861" providerId="ADAL" clId="{AD4CB5B1-1484-47F1-98AB-16FFBFDB40AB}" dt="2023-03-10T20:02:00.066" v="110" actId="1076"/>
          <ac:picMkLst>
            <pc:docMk/>
            <pc:sldMk cId="1957108625" sldId="264"/>
            <ac:picMk id="18" creationId="{81D68695-A474-17C8-6C03-0B667F8409AA}"/>
          </ac:picMkLst>
        </pc:picChg>
        <pc:picChg chg="add mod">
          <ac:chgData name="David L Williams" userId="94b5e154-46c7-48ee-9f2d-7b90dd615861" providerId="ADAL" clId="{AD4CB5B1-1484-47F1-98AB-16FFBFDB40AB}" dt="2023-03-10T20:02:55.196" v="114" actId="1076"/>
          <ac:picMkLst>
            <pc:docMk/>
            <pc:sldMk cId="1957108625" sldId="264"/>
            <ac:picMk id="19" creationId="{47B46407-3B29-62B9-EA5A-56B63BB878CA}"/>
          </ac:picMkLst>
        </pc:picChg>
      </pc:sldChg>
    </pc:docChg>
  </pc:docChgLst>
  <pc:docChgLst>
    <pc:chgData name="David L Williams" userId="94b5e154-46c7-48ee-9f2d-7b90dd615861" providerId="ADAL" clId="{68DCB936-AE90-4032-91F8-22ED0E466F7F}"/>
    <pc:docChg chg="delSld">
      <pc:chgData name="David L Williams" userId="94b5e154-46c7-48ee-9f2d-7b90dd615861" providerId="ADAL" clId="{68DCB936-AE90-4032-91F8-22ED0E466F7F}" dt="2023-05-30T18:02:50.146" v="2" actId="2696"/>
      <pc:docMkLst>
        <pc:docMk/>
      </pc:docMkLst>
      <pc:sldChg chg="del">
        <pc:chgData name="David L Williams" userId="94b5e154-46c7-48ee-9f2d-7b90dd615861" providerId="ADAL" clId="{68DCB936-AE90-4032-91F8-22ED0E466F7F}" dt="2023-05-30T18:02:38.055" v="0" actId="2696"/>
        <pc:sldMkLst>
          <pc:docMk/>
          <pc:sldMk cId="3768732664" sldId="261"/>
        </pc:sldMkLst>
      </pc:sldChg>
      <pc:sldChg chg="del">
        <pc:chgData name="David L Williams" userId="94b5e154-46c7-48ee-9f2d-7b90dd615861" providerId="ADAL" clId="{68DCB936-AE90-4032-91F8-22ED0E466F7F}" dt="2023-05-30T18:02:41.905" v="1" actId="2696"/>
        <pc:sldMkLst>
          <pc:docMk/>
          <pc:sldMk cId="1968887079" sldId="262"/>
        </pc:sldMkLst>
      </pc:sldChg>
      <pc:sldChg chg="del">
        <pc:chgData name="David L Williams" userId="94b5e154-46c7-48ee-9f2d-7b90dd615861" providerId="ADAL" clId="{68DCB936-AE90-4032-91F8-22ED0E466F7F}" dt="2023-05-30T18:02:50.146" v="2" actId="2696"/>
        <pc:sldMkLst>
          <pc:docMk/>
          <pc:sldMk cId="1957108625" sldId="264"/>
        </pc:sldMkLst>
      </pc:sldChg>
    </pc:docChg>
  </pc:docChgLst>
  <pc:docChgLst>
    <pc:chgData name="Samuel Aboagye" userId="bacaaf20-eadd-48c3-aff8-baa4e3eaa672" providerId="ADAL" clId="{F889ECC3-8F8A-45E9-B3A4-32D192B92442}"/>
    <pc:docChg chg="undo modSld">
      <pc:chgData name="Samuel Aboagye" userId="bacaaf20-eadd-48c3-aff8-baa4e3eaa672" providerId="ADAL" clId="{F889ECC3-8F8A-45E9-B3A4-32D192B92442}" dt="2023-05-25T19:58:33.654" v="1" actId="1076"/>
      <pc:docMkLst>
        <pc:docMk/>
      </pc:docMkLst>
      <pc:sldChg chg="modSp">
        <pc:chgData name="Samuel Aboagye" userId="bacaaf20-eadd-48c3-aff8-baa4e3eaa672" providerId="ADAL" clId="{F889ECC3-8F8A-45E9-B3A4-32D192B92442}" dt="2023-05-25T19:58:33.654" v="1" actId="1076"/>
        <pc:sldMkLst>
          <pc:docMk/>
          <pc:sldMk cId="1968887079" sldId="262"/>
        </pc:sldMkLst>
        <pc:picChg chg="mod">
          <ac:chgData name="Samuel Aboagye" userId="bacaaf20-eadd-48c3-aff8-baa4e3eaa672" providerId="ADAL" clId="{F889ECC3-8F8A-45E9-B3A4-32D192B92442}" dt="2023-05-25T19:58:33.654" v="1" actId="1076"/>
          <ac:picMkLst>
            <pc:docMk/>
            <pc:sldMk cId="1968887079" sldId="262"/>
            <ac:picMk id="22" creationId="{22BA6C49-CD70-488E-91BD-B0EB8B42674B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041296-ACAA-455F-81DD-E3AAB1A38596}" type="datetimeFigureOut">
              <a:rPr lang="en-US" smtClean="0"/>
              <a:t>5/30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776658-7F05-44C8-979A-A526F385B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837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804C7B-BE6B-4B47-8BD3-E7E452F9133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278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A69191-61F6-4365-8216-725600C4DC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26EDF5-F72C-42B3-9973-D0ACC7ECF3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9E8BE0-B94B-4CC0-B8C0-98CD46961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07D2D7-62FB-4D15-881A-DE9F92FFF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A7CE62-ECE3-4530-A666-05247CD815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353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5E4A04-87F9-4A2A-B228-17B26C55EA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A6894C-9094-44AA-B44F-21D23125A6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21-67A0-42F7-81EC-2C084D265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FD84AE-0745-4B6C-A225-7CB5E64BA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6A115B-3FC1-42E0-BEDB-D3731E005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366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8116B9-2F22-4974-9364-4A21976F0D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18599C-2F61-4409-A3E0-ECA8FBB00D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35259E-AE0A-4AC4-939C-ECBB43983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3E8919-938A-464A-8504-2DCBEFF56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BBFF46-DB17-4277-B63D-2DBE7CEA1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427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0873EF-3B0A-4FF0-9BDC-FB06AC0024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9D1CCC-8046-4216-A6FD-D01BED0021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ECC397-C9DB-42FC-A3FE-AF299AF98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B7DDBF-DAA9-43E3-ADA2-B6797BA51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4BC592-3213-4FDF-9B14-9FDDEC479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655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7A5B6-23FE-47A7-B2E0-61D7FFF2C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FB0335-4278-427C-B5C4-FBFF3EF5F0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0F38D3-02F0-46DA-92C4-9DF974023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3731E2-113E-45C9-A153-AA50FC0DA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3D3079-CD77-407C-9C84-CC73E7DB7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779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169DBA-55DE-4685-8C25-42AE31BAB2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540B4F-8E33-4610-BA9F-B919CC948C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7189CD-931A-4E7F-8B73-FD436C2A9D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C8F45D-C4B3-464D-9594-F0D1ABE78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C011A1-836F-4AB9-A956-AFDD2B313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97390A-4130-470D-A3D5-D8BBD9F86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292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B173EC-4E01-494C-A3C3-5157B35ED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09579A-2BB1-4ACA-A7D4-578555FF0F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C94FB6-3171-4B6B-B885-EA12B14944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B7DB31-A26E-42A4-88EC-A28A1F887D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49066A-5FF3-45DD-8650-7629BB21BC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7AFE5E4-B9D7-4284-AAA7-3D73D3E7C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23B2CC-B784-48C3-98B9-F33B08D28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6C7B65D-9291-48B6-AF18-227966FE7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11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7CFB6F-C342-4EA1-BCD0-BEA35B681B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F21F64-D1ED-4CE7-9CB2-B3D7B1EF7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1C7967-5922-4682-B83E-333CE36DE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9EFEA6-8463-4043-81AA-ED1655B49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207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ECD6DA-E736-4F07-8307-193F6AB28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936DB5-167F-4913-8A5A-E89B8E870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94718C3-73EF-476F-AA1C-26507BC94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852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A00FE-5E59-4D73-BE10-A314579F7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9BA1EB-2FA8-4D14-A082-320EFBCDB5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F483ED-CCBF-4403-B502-C6F5441672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5F007B-8770-4BC0-B527-34AD2289E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C2F044-100C-4345-8B54-61B806A1A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2B4781-EDE8-4DDF-9EDA-5216DCC56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456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DBDA0C-AE1D-442C-85E0-0D7FCE3C6E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D16C041-E51C-4F87-846B-0DAADA3112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C504E8-2DED-4D2C-B0DE-6A7FEE9AAC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2AC783-2048-40AB-9FF9-E1B3676416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95E364-349C-47BD-BEFD-733E3656A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F53391-AAD6-478B-BCF5-82335E436D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77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8A4B1F6-52DD-4309-833C-8EAA26C28D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AD14DA-33A2-40E7-A344-3D24062B0D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62724A-4431-4A1A-AF06-C9B9ECF214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5D9CB-FD37-4E3F-AF06-6A010215A2BA}" type="datetimeFigureOut">
              <a:rPr lang="en-US" smtClean="0"/>
              <a:t>5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17C5A6-799F-4F81-9047-5A29F0F017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FDE55A-F902-497A-B508-01EA42F696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BABA28-E916-4F10-8582-64293157A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444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microsoft.com/office/2007/relationships/media" Target="../media/media7.mp4"/><Relationship Id="rId18" Type="http://schemas.openxmlformats.org/officeDocument/2006/relationships/notesSlide" Target="../notesSlides/notesSlide1.xml"/><Relationship Id="rId26" Type="http://schemas.openxmlformats.org/officeDocument/2006/relationships/image" Target="../media/image8.png"/><Relationship Id="rId3" Type="http://schemas.microsoft.com/office/2007/relationships/media" Target="../media/media2.mp4"/><Relationship Id="rId21" Type="http://schemas.openxmlformats.org/officeDocument/2006/relationships/image" Target="../media/image3.png"/><Relationship Id="rId7" Type="http://schemas.microsoft.com/office/2007/relationships/media" Target="../media/media4.mp4"/><Relationship Id="rId12" Type="http://schemas.openxmlformats.org/officeDocument/2006/relationships/video" Target="../media/media6.mp4"/><Relationship Id="rId17" Type="http://schemas.openxmlformats.org/officeDocument/2006/relationships/slideLayout" Target="../slideLayouts/slideLayout7.xml"/><Relationship Id="rId25" Type="http://schemas.openxmlformats.org/officeDocument/2006/relationships/image" Target="../media/image7.png"/><Relationship Id="rId2" Type="http://schemas.openxmlformats.org/officeDocument/2006/relationships/video" Target="../media/media1.mp4"/><Relationship Id="rId16" Type="http://schemas.openxmlformats.org/officeDocument/2006/relationships/video" Target="../media/media8.mp4"/><Relationship Id="rId20" Type="http://schemas.openxmlformats.org/officeDocument/2006/relationships/image" Target="../media/image2.png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microsoft.com/office/2007/relationships/media" Target="../media/media6.mp4"/><Relationship Id="rId24" Type="http://schemas.openxmlformats.org/officeDocument/2006/relationships/image" Target="../media/image6.png"/><Relationship Id="rId5" Type="http://schemas.microsoft.com/office/2007/relationships/media" Target="../media/media3.mp4"/><Relationship Id="rId15" Type="http://schemas.microsoft.com/office/2007/relationships/media" Target="../media/media8.mp4"/><Relationship Id="rId23" Type="http://schemas.openxmlformats.org/officeDocument/2006/relationships/image" Target="../media/image5.png"/><Relationship Id="rId10" Type="http://schemas.openxmlformats.org/officeDocument/2006/relationships/video" Target="../media/media5.mp4"/><Relationship Id="rId19" Type="http://schemas.openxmlformats.org/officeDocument/2006/relationships/image" Target="../media/image1.png"/><Relationship Id="rId4" Type="http://schemas.openxmlformats.org/officeDocument/2006/relationships/video" Target="../media/media2.mp4"/><Relationship Id="rId9" Type="http://schemas.microsoft.com/office/2007/relationships/media" Target="../media/media5.mp4"/><Relationship Id="rId14" Type="http://schemas.openxmlformats.org/officeDocument/2006/relationships/video" Target="../media/media7.mp4"/><Relationship Id="rId22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2C08C7F-1555-4700-98CA-5D02EE1362C2}"/>
              </a:ext>
            </a:extLst>
          </p:cNvPr>
          <p:cNvSpPr/>
          <p:nvPr/>
        </p:nvSpPr>
        <p:spPr>
          <a:xfrm>
            <a:off x="338098" y="1750703"/>
            <a:ext cx="11668250" cy="18466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NTS were exposed to different concentrations of PZQ, and viability was assessed phenotypically after 24 </a:t>
            </a:r>
            <a:r>
              <a:rPr lang="en-US" sz="120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, 72 </a:t>
            </a:r>
            <a:r>
              <a:rPr lang="en-US" sz="120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, and 168 </a:t>
            </a:r>
            <a:r>
              <a:rPr lang="en-US" sz="120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 following Lombardo et al., 2019.</a:t>
            </a:r>
          </a:p>
          <a:p>
            <a:pPr marL="171450" indent="-171450">
              <a:buFont typeface="Wingdings" panose="05000000000000000000" pitchFamily="2" charset="2"/>
              <a:buChar char="§"/>
            </a:pP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Scoring criteria </a:t>
            </a:r>
          </a:p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3 = motile, no changes to morphology or transparency;</a:t>
            </a:r>
          </a:p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	2 = reduced motility and/or some damage to tegument noted, as well as reduced transparency and granularity;</a:t>
            </a:r>
          </a:p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	1 = severe reduction of motility and/or damage to tegument observed, with high opacity and high granularity; </a:t>
            </a:r>
          </a:p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	0 = dead.</a:t>
            </a:r>
          </a:p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PZQ 24 </a:t>
            </a:r>
            <a:r>
              <a:rPr lang="en-US" sz="120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 scoring data are on the last slide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B6D10D1-DA43-46FA-AA22-685F880B1CE3}"/>
              </a:ext>
            </a:extLst>
          </p:cNvPr>
          <p:cNvSpPr/>
          <p:nvPr/>
        </p:nvSpPr>
        <p:spPr>
          <a:xfrm>
            <a:off x="3499804" y="629339"/>
            <a:ext cx="60100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>
                <a:latin typeface="AdvOT5777b7ad"/>
              </a:rPr>
              <a:t>Phenotypic assessment of viability of NTS upon PZQ exposure</a:t>
            </a:r>
            <a:endParaRPr lang="en-US" b="1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3DFF6FF-C3DB-4A87-89CD-09E42BAD3CBF}"/>
              </a:ext>
            </a:extLst>
          </p:cNvPr>
          <p:cNvSpPr txBox="1"/>
          <p:nvPr/>
        </p:nvSpPr>
        <p:spPr>
          <a:xfrm>
            <a:off x="338098" y="4318448"/>
            <a:ext cx="1107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>
                <a:latin typeface="Arial" panose="020B0604020202020204" pitchFamily="34" charset="0"/>
                <a:cs typeface="Arial" panose="020B0604020202020204" pitchFamily="34" charset="0"/>
              </a:rPr>
              <a:t>Reference</a:t>
            </a:r>
          </a:p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Lombardo, F.C., </a:t>
            </a:r>
            <a:r>
              <a:rPr lang="en-US" sz="1200" err="1">
                <a:latin typeface="Arial" panose="020B0604020202020204" pitchFamily="34" charset="0"/>
                <a:cs typeface="Arial" panose="020B0604020202020204" pitchFamily="34" charset="0"/>
              </a:rPr>
              <a:t>Pasche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, V., Panic, G. </a:t>
            </a:r>
            <a:r>
              <a:rPr lang="en-US" sz="1200" i="1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 Life cycle maintenance and drug-sensitivity assays for early  drug discovery in </a:t>
            </a:r>
            <a:r>
              <a:rPr lang="en-US" sz="1200" i="1">
                <a:latin typeface="Arial" panose="020B0604020202020204" pitchFamily="34" charset="0"/>
                <a:cs typeface="Arial" panose="020B0604020202020204" pitchFamily="34" charset="0"/>
              </a:rPr>
              <a:t>Schistosoma mansoni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. </a:t>
            </a:r>
            <a:r>
              <a:rPr lang="en-US" sz="1200" i="1">
                <a:latin typeface="Arial" panose="020B0604020202020204" pitchFamily="34" charset="0"/>
                <a:cs typeface="Arial" panose="020B0604020202020204" pitchFamily="34" charset="0"/>
              </a:rPr>
              <a:t>Nat </a:t>
            </a:r>
            <a:r>
              <a:rPr lang="en-US" sz="1200" i="1" err="1">
                <a:latin typeface="Arial" panose="020B0604020202020204" pitchFamily="34" charset="0"/>
                <a:cs typeface="Arial" panose="020B0604020202020204" pitchFamily="34" charset="0"/>
              </a:rPr>
              <a:t>Protoc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, 461–481 (2019). https://doi.org/10.1038/s41596-018-0101-y</a:t>
            </a:r>
          </a:p>
        </p:txBody>
      </p:sp>
    </p:spTree>
    <p:extLst>
      <p:ext uri="{BB962C8B-B14F-4D97-AF65-F5344CB8AC3E}">
        <p14:creationId xmlns:p14="http://schemas.microsoft.com/office/powerpoint/2010/main" val="25159794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NTS_NoDrug">
            <a:hlinkClick r:id="" action="ppaction://media"/>
            <a:extLst>
              <a:ext uri="{FF2B5EF4-FFF2-40B4-BE49-F238E27FC236}">
                <a16:creationId xmlns:a16="http://schemas.microsoft.com/office/drawing/2014/main" id="{AFC2D119-056A-4F0D-B798-18A13E96FA1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19"/>
          <a:srcRect l="28617" t="13531" r="27301" b="30551"/>
          <a:stretch/>
        </p:blipFill>
        <p:spPr>
          <a:xfrm>
            <a:off x="793283" y="817166"/>
            <a:ext cx="2575250" cy="245006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7C623C0-2C8C-4C5C-A83A-4DC68BF42629}"/>
              </a:ext>
            </a:extLst>
          </p:cNvPr>
          <p:cNvSpPr txBox="1"/>
          <p:nvPr/>
        </p:nvSpPr>
        <p:spPr>
          <a:xfrm>
            <a:off x="686000" y="50021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pic>
        <p:nvPicPr>
          <p:cNvPr id="4" name="NTS_10uM">
            <a:hlinkClick r:id="" action="ppaction://media"/>
            <a:extLst>
              <a:ext uri="{FF2B5EF4-FFF2-40B4-BE49-F238E27FC236}">
                <a16:creationId xmlns:a16="http://schemas.microsoft.com/office/drawing/2014/main" id="{E45B8DB7-D3B5-4ED5-8447-1C71E9A28FE0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20"/>
          <a:srcRect l="36270" t="18429" r="20158" b="27694"/>
          <a:stretch/>
        </p:blipFill>
        <p:spPr>
          <a:xfrm>
            <a:off x="9135707" y="814844"/>
            <a:ext cx="2575250" cy="2450065"/>
          </a:xfrm>
          <a:prstGeom prst="rect">
            <a:avLst/>
          </a:prstGeom>
        </p:spPr>
      </p:pic>
      <p:pic>
        <p:nvPicPr>
          <p:cNvPr id="5" name="NTS_20uM">
            <a:hlinkClick r:id="" action="ppaction://media"/>
            <a:extLst>
              <a:ext uri="{FF2B5EF4-FFF2-40B4-BE49-F238E27FC236}">
                <a16:creationId xmlns:a16="http://schemas.microsoft.com/office/drawing/2014/main" id="{9A52A31D-8B82-4366-8C18-C0DA95A5432E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21"/>
          <a:srcRect l="30046" t="19381" r="24444" b="25245"/>
          <a:stretch/>
        </p:blipFill>
        <p:spPr>
          <a:xfrm>
            <a:off x="796869" y="3560362"/>
            <a:ext cx="2575250" cy="245006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76C3BC9-D184-4FF5-A8FC-48B2823FCEBF}"/>
              </a:ext>
            </a:extLst>
          </p:cNvPr>
          <p:cNvSpPr txBox="1"/>
          <p:nvPr/>
        </p:nvSpPr>
        <p:spPr>
          <a:xfrm>
            <a:off x="3501801" y="49037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D98115-0B7E-47ED-A639-8BA64CF9252D}"/>
              </a:ext>
            </a:extLst>
          </p:cNvPr>
          <p:cNvSpPr txBox="1"/>
          <p:nvPr/>
        </p:nvSpPr>
        <p:spPr>
          <a:xfrm>
            <a:off x="696420" y="319103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</a:t>
            </a:r>
          </a:p>
        </p:txBody>
      </p:sp>
      <p:pic>
        <p:nvPicPr>
          <p:cNvPr id="8" name="NTS_30uM">
            <a:hlinkClick r:id="" action="ppaction://media"/>
            <a:extLst>
              <a:ext uri="{FF2B5EF4-FFF2-40B4-BE49-F238E27FC236}">
                <a16:creationId xmlns:a16="http://schemas.microsoft.com/office/drawing/2014/main" id="{D5450738-57BD-44DC-8E11-C3A30041B8EA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 rotWithShape="1">
          <a:blip r:embed="rId22"/>
          <a:srcRect l="21679" t="23327" r="31893" b="25108"/>
          <a:stretch/>
        </p:blipFill>
        <p:spPr>
          <a:xfrm>
            <a:off x="3612864" y="3560363"/>
            <a:ext cx="2575250" cy="245006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A1F461D-304F-4180-A065-7B1D1530F8FF}"/>
              </a:ext>
            </a:extLst>
          </p:cNvPr>
          <p:cNvSpPr txBox="1"/>
          <p:nvPr/>
        </p:nvSpPr>
        <p:spPr>
          <a:xfrm>
            <a:off x="3513765" y="321581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</a:t>
            </a:r>
          </a:p>
        </p:txBody>
      </p:sp>
      <p:pic>
        <p:nvPicPr>
          <p:cNvPr id="10" name="NTS_40uM">
            <a:hlinkClick r:id="" action="ppaction://media"/>
            <a:extLst>
              <a:ext uri="{FF2B5EF4-FFF2-40B4-BE49-F238E27FC236}">
                <a16:creationId xmlns:a16="http://schemas.microsoft.com/office/drawing/2014/main" id="{ED5999F9-4E74-4B1D-A43A-81E2A339E233}"/>
              </a:ext>
            </a:extLst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 rotWithShape="1">
          <a:blip r:embed="rId23"/>
          <a:srcRect l="27189" t="21151" r="32607" b="28237"/>
          <a:stretch/>
        </p:blipFill>
        <p:spPr>
          <a:xfrm>
            <a:off x="6383164" y="3560364"/>
            <a:ext cx="2575250" cy="2450065"/>
          </a:xfrm>
          <a:prstGeom prst="rect">
            <a:avLst/>
          </a:prstGeom>
        </p:spPr>
      </p:pic>
      <p:pic>
        <p:nvPicPr>
          <p:cNvPr id="11" name="NTS_50uM">
            <a:hlinkClick r:id="" action="ppaction://media"/>
            <a:extLst>
              <a:ext uri="{FF2B5EF4-FFF2-40B4-BE49-F238E27FC236}">
                <a16:creationId xmlns:a16="http://schemas.microsoft.com/office/drawing/2014/main" id="{E07D8C6F-C997-40A1-A3B7-6E7FDD7915ED}"/>
              </a:ext>
            </a:extLst>
          </p:cNvPr>
          <p:cNvPicPr>
            <a:picLocks noChangeAspect="1"/>
          </p:cNvPicPr>
          <p:nvPr>
            <a:vide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 rotWithShape="1">
          <a:blip r:embed="rId24"/>
          <a:srcRect l="22597" t="18701" r="27913" b="21708"/>
          <a:stretch/>
        </p:blipFill>
        <p:spPr>
          <a:xfrm>
            <a:off x="9135707" y="3560365"/>
            <a:ext cx="2575250" cy="245006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52DC85E-0BF5-4224-9F76-8A269740B85E}"/>
              </a:ext>
            </a:extLst>
          </p:cNvPr>
          <p:cNvSpPr txBox="1"/>
          <p:nvPr/>
        </p:nvSpPr>
        <p:spPr>
          <a:xfrm>
            <a:off x="6256804" y="3227971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885747-083B-4B5C-8CA8-4DB1AE2BA203}"/>
              </a:ext>
            </a:extLst>
          </p:cNvPr>
          <p:cNvSpPr txBox="1"/>
          <p:nvPr/>
        </p:nvSpPr>
        <p:spPr>
          <a:xfrm>
            <a:off x="9039919" y="3260015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2EDA8C2-BB6D-4B78-B0D6-44A1E3782A81}"/>
              </a:ext>
            </a:extLst>
          </p:cNvPr>
          <p:cNvSpPr txBox="1"/>
          <p:nvPr/>
        </p:nvSpPr>
        <p:spPr>
          <a:xfrm>
            <a:off x="2436740" y="6088114"/>
            <a:ext cx="780694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/>
              <a:t>Schistosomicidal effect of PZQ on NTS after 24-hour exposure at A) no drug treatment, B) 1 </a:t>
            </a:r>
            <a:r>
              <a:rPr lang="en-US" sz="1100">
                <a:cs typeface="Calibri" panose="020F0502020204030204" pitchFamily="34" charset="0"/>
              </a:rPr>
              <a:t>µM PZQ, C) </a:t>
            </a:r>
            <a:r>
              <a:rPr lang="en-US" sz="1100"/>
              <a:t>5 </a:t>
            </a:r>
            <a:r>
              <a:rPr lang="en-US" sz="1100">
                <a:cs typeface="Calibri" panose="020F0502020204030204" pitchFamily="34" charset="0"/>
              </a:rPr>
              <a:t>µM PZQ, </a:t>
            </a:r>
          </a:p>
          <a:p>
            <a:pPr algn="ctr"/>
            <a:r>
              <a:rPr lang="en-US" sz="1100"/>
              <a:t>D) 10 </a:t>
            </a:r>
            <a:r>
              <a:rPr lang="en-US" sz="1100">
                <a:cs typeface="Calibri" panose="020F0502020204030204" pitchFamily="34" charset="0"/>
              </a:rPr>
              <a:t>µM PZQ, </a:t>
            </a:r>
            <a:r>
              <a:rPr lang="en-US" sz="1100"/>
              <a:t>E) 20 </a:t>
            </a:r>
            <a:r>
              <a:rPr lang="en-US" sz="1100">
                <a:cs typeface="Calibri" panose="020F0502020204030204" pitchFamily="34" charset="0"/>
              </a:rPr>
              <a:t>µM PZQ, F</a:t>
            </a:r>
            <a:r>
              <a:rPr lang="en-US" sz="1100"/>
              <a:t>) 30 </a:t>
            </a:r>
            <a:r>
              <a:rPr lang="en-US" sz="1100">
                <a:cs typeface="Calibri" panose="020F0502020204030204" pitchFamily="34" charset="0"/>
              </a:rPr>
              <a:t>µM PZQ, G</a:t>
            </a:r>
            <a:r>
              <a:rPr lang="en-US" sz="1100"/>
              <a:t>) 40 </a:t>
            </a:r>
            <a:r>
              <a:rPr lang="en-US" sz="1100">
                <a:cs typeface="Calibri" panose="020F0502020204030204" pitchFamily="34" charset="0"/>
              </a:rPr>
              <a:t>µM PZQ and H</a:t>
            </a:r>
            <a:r>
              <a:rPr lang="en-US" sz="1100"/>
              <a:t>) 50 </a:t>
            </a:r>
            <a:r>
              <a:rPr lang="en-US" sz="1100">
                <a:cs typeface="Calibri" panose="020F0502020204030204" pitchFamily="34" charset="0"/>
              </a:rPr>
              <a:t>µM PZQ. A representative video is shown from triplicate assays.</a:t>
            </a:r>
            <a:endParaRPr lang="en-US" sz="1100"/>
          </a:p>
        </p:txBody>
      </p:sp>
      <p:pic>
        <p:nvPicPr>
          <p:cNvPr id="15" name="1uM">
            <a:hlinkClick r:id="" action="ppaction://media"/>
            <a:extLst>
              <a:ext uri="{FF2B5EF4-FFF2-40B4-BE49-F238E27FC236}">
                <a16:creationId xmlns:a16="http://schemas.microsoft.com/office/drawing/2014/main" id="{6AC8D626-036C-4E4D-9EBC-6127917D7142}"/>
              </a:ext>
            </a:extLst>
          </p:cNvPr>
          <p:cNvPicPr>
            <a:picLocks noChangeAspect="1"/>
          </p:cNvPicPr>
          <p:nvPr>
            <a:videoFile r:link="rId14"/>
            <p:extLst>
              <p:ext uri="{DAA4B4D4-6D71-4841-9C94-3DE7FCFB9230}">
                <p14:media xmlns:p14="http://schemas.microsoft.com/office/powerpoint/2010/main" r:embed="rId13"/>
              </p:ext>
            </p:extLst>
          </p:nvPr>
        </p:nvPicPr>
        <p:blipFill rotWithShape="1">
          <a:blip r:embed="rId25"/>
          <a:srcRect l="24887" t="22907" r="30784" b="28652"/>
          <a:stretch/>
        </p:blipFill>
        <p:spPr>
          <a:xfrm>
            <a:off x="3594033" y="817165"/>
            <a:ext cx="2594082" cy="2450065"/>
          </a:xfrm>
          <a:prstGeom prst="rect">
            <a:avLst/>
          </a:prstGeom>
        </p:spPr>
      </p:pic>
      <p:pic>
        <p:nvPicPr>
          <p:cNvPr id="16" name="5uM">
            <a:hlinkClick r:id="" action="ppaction://media"/>
            <a:extLst>
              <a:ext uri="{FF2B5EF4-FFF2-40B4-BE49-F238E27FC236}">
                <a16:creationId xmlns:a16="http://schemas.microsoft.com/office/drawing/2014/main" id="{E845ABEE-B9EC-422D-B260-80D02AC5D951}"/>
              </a:ext>
            </a:extLst>
          </p:cNvPr>
          <p:cNvPicPr>
            <a:picLocks noChangeAspect="1"/>
          </p:cNvPicPr>
          <p:nvPr>
            <a:videoFile r:link="rId16"/>
            <p:extLst>
              <p:ext uri="{DAA4B4D4-6D71-4841-9C94-3DE7FCFB9230}">
                <p14:media xmlns:p14="http://schemas.microsoft.com/office/powerpoint/2010/main" r:embed="rId15"/>
              </p:ext>
            </p:extLst>
          </p:nvPr>
        </p:nvPicPr>
        <p:blipFill rotWithShape="1">
          <a:blip r:embed="rId26"/>
          <a:srcRect l="29566" t="22173" r="31620" b="22169"/>
          <a:stretch/>
        </p:blipFill>
        <p:spPr>
          <a:xfrm>
            <a:off x="6340213" y="827253"/>
            <a:ext cx="2618201" cy="243997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5D0F2C06-F37D-4990-ADBD-62A7506DC8A1}"/>
              </a:ext>
            </a:extLst>
          </p:cNvPr>
          <p:cNvSpPr txBox="1"/>
          <p:nvPr/>
        </p:nvSpPr>
        <p:spPr>
          <a:xfrm>
            <a:off x="6224306" y="50021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6CE30DC-51E0-496D-BF07-AB71096B0FF3}"/>
              </a:ext>
            </a:extLst>
          </p:cNvPr>
          <p:cNvSpPr txBox="1"/>
          <p:nvPr/>
        </p:nvSpPr>
        <p:spPr>
          <a:xfrm>
            <a:off x="9018121" y="49037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9934659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886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962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10035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2" dur="10035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6" dur="10035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0" dur="9863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4" dur="10035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35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36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7" fill="hold">
                      <p:stCondLst>
                        <p:cond delay="0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0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41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4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3" fill="hold">
                      <p:stCondLst>
                        <p:cond delay="0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4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4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9" fill="hold">
                      <p:stCondLst>
                        <p:cond delay="0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5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53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54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55" fill="hold">
                      <p:stCondLst>
                        <p:cond delay="0"/>
                      </p:stCondLst>
                      <p:childTnLst>
                        <p:par>
                          <p:cTn id="56" fill="hold">
                            <p:stCondLst>
                              <p:cond delay="0"/>
                            </p:stCondLst>
                            <p:childTnLst>
                              <p:par>
                                <p:cTn id="5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58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59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60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61" fill="hold">
                      <p:stCondLst>
                        <p:cond delay="0"/>
                      </p:stCondLst>
                      <p:childTnLst>
                        <p:par>
                          <p:cTn id="62" fill="hold">
                            <p:stCondLst>
                              <p:cond delay="0"/>
                            </p:stCondLst>
                            <p:childTnLst>
                              <p:par>
                                <p:cTn id="6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4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65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seq concurrent="1" nextAc="seek">
              <p:cTn id="66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67" fill="hold">
                      <p:stCondLst>
                        <p:cond delay="0"/>
                      </p:stCondLst>
                      <p:childTnLst>
                        <p:par>
                          <p:cTn id="68" fill="hold">
                            <p:stCondLst>
                              <p:cond delay="0"/>
                            </p:stCondLst>
                            <p:childTnLst>
                              <p:par>
                                <p:cTn id="6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70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71" fill="hold" display="0">
                  <p:stCondLst>
                    <p:cond delay="indefinite"/>
                  </p:stCondLst>
                </p:cTn>
                <p:tgtEl>
                  <p:spTgt spid="15"/>
                </p:tgtEl>
              </p:cMediaNode>
            </p:video>
            <p:seq concurrent="1" nextAc="seek">
              <p:cTn id="72" restart="whenNotActive" fill="hold" evtFilter="cancelBubble" nodeType="interactiveSeq">
                <p:stCondLst>
                  <p:cond evt="onClick" delay="0">
                    <p:tgtEl>
                      <p:spTgt spid="1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73" fill="hold">
                      <p:stCondLst>
                        <p:cond delay="0"/>
                      </p:stCondLst>
                      <p:childTnLst>
                        <p:par>
                          <p:cTn id="74" fill="hold">
                            <p:stCondLst>
                              <p:cond delay="0"/>
                            </p:stCondLst>
                            <p:childTnLst>
                              <p:par>
                                <p:cTn id="7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76" dur="1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5"/>
                  </p:tgtEl>
                </p:cond>
              </p:nextCondLst>
            </p:seq>
            <p:video>
              <p:cMediaNode vol="80000">
                <p:cTn id="77" fill="hold" display="0">
                  <p:stCondLst>
                    <p:cond delay="indefinite"/>
                  </p:stCondLst>
                </p:cTn>
                <p:tgtEl>
                  <p:spTgt spid="16"/>
                </p:tgtEl>
              </p:cMediaNode>
            </p:video>
            <p:seq concurrent="1" nextAc="seek">
              <p:cTn id="78" restart="whenNotActive" fill="hold" evtFilter="cancelBubble" nodeType="interactiveSeq">
                <p:stCondLst>
                  <p:cond evt="onClick" delay="0">
                    <p:tgtEl>
                      <p:spTgt spid="1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79" fill="hold">
                      <p:stCondLst>
                        <p:cond delay="0"/>
                      </p:stCondLst>
                      <p:childTnLst>
                        <p:par>
                          <p:cTn id="80" fill="hold">
                            <p:stCondLst>
                              <p:cond delay="0"/>
                            </p:stCondLst>
                            <p:childTnLst>
                              <p:par>
                                <p:cTn id="8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82" dur="1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BC52A96E6A39E429BFF2487DAC73563" ma:contentTypeVersion="15" ma:contentTypeDescription="Create a new document." ma:contentTypeScope="" ma:versionID="9a3b272770e2b92cb46126cb1f6c21af">
  <xsd:schema xmlns:xsd="http://www.w3.org/2001/XMLSchema" xmlns:xs="http://www.w3.org/2001/XMLSchema" xmlns:p="http://schemas.microsoft.com/office/2006/metadata/properties" xmlns:ns2="a94bb81d-db34-4761-9da7-2ff07b5bb6d9" xmlns:ns3="2d4c6dd8-27c7-4424-ac36-2b50d79587fb" targetNamespace="http://schemas.microsoft.com/office/2006/metadata/properties" ma:root="true" ma:fieldsID="6870b613834ea22bf256c5630ba2b95b" ns2:_="" ns3:_="">
    <xsd:import namespace="a94bb81d-db34-4761-9da7-2ff07b5bb6d9"/>
    <xsd:import namespace="2d4c6dd8-27c7-4424-ac36-2b50d79587f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ServiceOCR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4bb81d-db34-4761-9da7-2ff07b5bb6d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59009afd-1226-4d6a-ba53-0e738375666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d4c6dd8-27c7-4424-ac36-2b50d79587fb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707a387d-c615-41df-8036-3d895b65cf4f}" ma:internalName="TaxCatchAll" ma:showField="CatchAllData" ma:web="2d4c6dd8-27c7-4424-ac36-2b50d79587f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a94bb81d-db34-4761-9da7-2ff07b5bb6d9">
      <Terms xmlns="http://schemas.microsoft.com/office/infopath/2007/PartnerControls"/>
    </lcf76f155ced4ddcb4097134ff3c332f>
    <TaxCatchAll xmlns="2d4c6dd8-27c7-4424-ac36-2b50d79587fb" xsi:nil="true"/>
  </documentManagement>
</p:properties>
</file>

<file path=customXml/itemProps1.xml><?xml version="1.0" encoding="utf-8"?>
<ds:datastoreItem xmlns:ds="http://schemas.openxmlformats.org/officeDocument/2006/customXml" ds:itemID="{CF437A2B-C10D-490B-8597-FC2F06F8A0E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25D9E56-AA88-49B4-A917-4B9F0B4A422E}">
  <ds:schemaRefs>
    <ds:schemaRef ds:uri="2d4c6dd8-27c7-4424-ac36-2b50d79587fb"/>
    <ds:schemaRef ds:uri="a94bb81d-db34-4761-9da7-2ff07b5bb6d9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DB310D26-B35E-4249-91D0-F40FE9D624D7}">
  <ds:schemaRefs>
    <ds:schemaRef ds:uri="2d4c6dd8-27c7-4424-ac36-2b50d79587fb"/>
    <ds:schemaRef ds:uri="a94bb81d-db34-4761-9da7-2ff07b5bb6d9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8</Words>
  <Application>Microsoft Macintosh PowerPoint</Application>
  <PresentationFormat>Widescreen</PresentationFormat>
  <Paragraphs>23</Paragraphs>
  <Slides>2</Slides>
  <Notes>1</Notes>
  <HiddenSlides>0</HiddenSlides>
  <MMClips>8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dvOT5777b7ad</vt:lpstr>
      <vt:lpstr>Arial</vt:lpstr>
      <vt:lpstr>Calibri</vt:lpstr>
      <vt:lpstr>Calibri Light</vt:lpstr>
      <vt:lpstr>Wingdings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uel Aboagye</dc:creator>
  <cp:lastModifiedBy>Petukhov, Pavel A</cp:lastModifiedBy>
  <cp:revision>1</cp:revision>
  <dcterms:created xsi:type="dcterms:W3CDTF">2023-02-21T21:52:39Z</dcterms:created>
  <dcterms:modified xsi:type="dcterms:W3CDTF">2023-05-30T18:15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BC52A96E6A39E429BFF2487DAC73563</vt:lpwstr>
  </property>
  <property fmtid="{D5CDD505-2E9C-101B-9397-08002B2CF9AE}" pid="3" name="MediaServiceImageTags">
    <vt:lpwstr/>
  </property>
</Properties>
</file>